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424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565" userDrawn="1">
          <p15:clr>
            <a:srgbClr val="A4A3A4"/>
          </p15:clr>
        </p15:guide>
        <p15:guide id="5" orient="horz" pos="5470" userDrawn="1">
          <p15:clr>
            <a:srgbClr val="A4A3A4"/>
          </p15:clr>
        </p15:guide>
        <p15:guide id="7" pos="2160" userDrawn="1">
          <p15:clr>
            <a:srgbClr val="A4A3A4"/>
          </p15:clr>
        </p15:guide>
        <p15:guide id="8" orient="horz" pos="879" userDrawn="1">
          <p15:clr>
            <a:srgbClr val="A4A3A4"/>
          </p15:clr>
        </p15:guide>
        <p15:guide id="9" pos="2727" userDrawn="1">
          <p15:clr>
            <a:srgbClr val="A4A3A4"/>
          </p15:clr>
        </p15:guide>
        <p15:guide id="10" pos="2750" userDrawn="1">
          <p15:clr>
            <a:srgbClr val="A4A3A4"/>
          </p15:clr>
        </p15:guide>
        <p15:guide id="11" orient="horz" pos="770" userDrawn="1">
          <p15:clr>
            <a:srgbClr val="A4A3A4"/>
          </p15:clr>
        </p15:guide>
        <p15:guide id="12" orient="horz" pos="66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249FF"/>
    <a:srgbClr val="FFFE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7510"/>
    <p:restoredTop sz="94444"/>
  </p:normalViewPr>
  <p:slideViewPr>
    <p:cSldViewPr snapToGrid="0" snapToObjects="1">
      <p:cViewPr varScale="1">
        <p:scale>
          <a:sx n="73" d="100"/>
          <a:sy n="73" d="100"/>
        </p:scale>
        <p:origin x="504" y="200"/>
      </p:cViewPr>
      <p:guideLst>
        <p:guide orient="horz" pos="5565"/>
        <p:guide orient="horz" pos="5470"/>
        <p:guide pos="2160"/>
        <p:guide orient="horz" pos="879"/>
        <p:guide pos="2727"/>
        <p:guide pos="2750"/>
        <p:guide orient="horz" pos="770"/>
        <p:guide orient="horz" pos="66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BC56DB-7ED9-E547-B56C-B88B6FEC3E07}" type="datetimeFigureOut">
              <a:rPr lang="en-US" smtClean="0"/>
              <a:t>3/11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F4B0B5-EE68-F745-8FD0-E985A50751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5445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8F4B0B5-EE68-F745-8FD0-E985A507518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1309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7771DC-BC44-E448-A3B8-F15989FB5E38}" type="datetimeFigureOut">
              <a:rPr lang="en-US" smtClean="0"/>
              <a:t>3/11/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FB5E08-76BA-C549-AC69-15552EAB305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4341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8">
            <a:extLst>
              <a:ext uri="{FF2B5EF4-FFF2-40B4-BE49-F238E27FC236}">
                <a16:creationId xmlns:a16="http://schemas.microsoft.com/office/drawing/2014/main" id="{9B4E6A56-1914-BB44-92D2-772C6DE047E1}"/>
              </a:ext>
            </a:extLst>
          </p:cNvPr>
          <p:cNvSpPr txBox="1"/>
          <p:nvPr/>
        </p:nvSpPr>
        <p:spPr>
          <a:xfrm>
            <a:off x="3932880" y="4234"/>
            <a:ext cx="29209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Supplementary Figure 6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693FF62-1F42-9C45-AD36-FB33DB6BC54A}"/>
              </a:ext>
            </a:extLst>
          </p:cNvPr>
          <p:cNvSpPr txBox="1"/>
          <p:nvPr/>
        </p:nvSpPr>
        <p:spPr>
          <a:xfrm>
            <a:off x="896026" y="608750"/>
            <a:ext cx="328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8AEB2E5-DDE2-3844-A780-4EA411A694E2}"/>
              </a:ext>
            </a:extLst>
          </p:cNvPr>
          <p:cNvSpPr txBox="1"/>
          <p:nvPr/>
        </p:nvSpPr>
        <p:spPr>
          <a:xfrm>
            <a:off x="4325545" y="608750"/>
            <a:ext cx="328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B</a:t>
            </a:r>
          </a:p>
        </p:txBody>
      </p:sp>
      <p:sp>
        <p:nvSpPr>
          <p:cNvPr id="8" name="テキスト ボックス 8">
            <a:extLst>
              <a:ext uri="{FF2B5EF4-FFF2-40B4-BE49-F238E27FC236}">
                <a16:creationId xmlns:a16="http://schemas.microsoft.com/office/drawing/2014/main" id="{8C9CC3DA-C6E8-0A43-AED9-33ECD5C7C96E}"/>
              </a:ext>
            </a:extLst>
          </p:cNvPr>
          <p:cNvSpPr txBox="1"/>
          <p:nvPr/>
        </p:nvSpPr>
        <p:spPr>
          <a:xfrm>
            <a:off x="521212" y="3292401"/>
            <a:ext cx="5822831" cy="2204509"/>
          </a:xfrm>
          <a:prstGeom prst="rect">
            <a:avLst/>
          </a:prstGeom>
          <a:noFill/>
        </p:spPr>
        <p:txBody>
          <a:bodyPr wrap="square">
            <a:noAutofit/>
          </a:bodyPr>
          <a:lstStyle/>
          <a:p>
            <a:pPr algn="just"/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Supplementary Figure 6 The influence of wortmannin (WM)</a:t>
            </a:r>
            <a:r>
              <a:rPr lang="en-US" sz="1400" b="1" i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 </a:t>
            </a:r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on Abe-/</a:t>
            </a:r>
            <a:r>
              <a:rPr lang="en-US" sz="1400" b="1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Vac</a:t>
            </a:r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</a:rPr>
              <a:t>- facilitated autophagic flux in SH-SY5Y cells</a:t>
            </a:r>
          </a:p>
          <a:p>
            <a:pPr algn="just"/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H-SY5Y cells stably expressing </a:t>
            </a:r>
            <a:r>
              <a:rPr lang="en-US" sz="14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GFP-LC3-RFP-LC3</a:t>
            </a:r>
            <a:r>
              <a:rPr lang="en-US" altLang="ja-JP" sz="14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ΔG</a:t>
            </a:r>
            <a:r>
              <a:rPr lang="en-US" altLang="ja-JP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were exposed to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vehicle (DMSO), 2 </a:t>
            </a:r>
            <a:r>
              <a:rPr lang="en-US" altLang="ja-JP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μ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Abe, 100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nM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Vac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, 1 </a:t>
            </a:r>
            <a:r>
              <a:rPr lang="en-US" altLang="ja-JP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μ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WM, 1 </a:t>
            </a:r>
            <a:r>
              <a:rPr lang="en-US" altLang="ja-JP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μ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WM plus 2 </a:t>
            </a:r>
            <a:r>
              <a:rPr lang="en-US" altLang="ja-JP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μ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Abe, or 1 </a:t>
            </a:r>
            <a:r>
              <a:rPr lang="en-US" altLang="ja-JP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μ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WM plus 100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nM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Vac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for 24 hrs. 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(</a:t>
            </a:r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A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)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Representative immunoblots (GFP, RFP, and </a:t>
            </a:r>
            <a:r>
              <a:rPr lang="en-US" altLang="ja-JP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α-tubulin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 are shown. 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(</a:t>
            </a:r>
            <a:r>
              <a:rPr lang="en-US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B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) Densitometric data on GFP and RFP were determined from immunoblotting results, and the GFP/RFP ratio normalized </a:t>
            </a:r>
            <a:r>
              <a:rPr lang="en-US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againinst</a:t>
            </a:r>
            <a:r>
              <a:rPr lang="en-US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cells exposed to DMSO was shown. Bar graphs data presented as means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± S.E.M. (</a:t>
            </a:r>
            <a:r>
              <a:rPr lang="en-US" sz="1400" i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N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= 3). * indicates P &lt;0.05 by the two-tailed unpaired </a:t>
            </a:r>
            <a:r>
              <a:rPr lang="en-US" sz="1400" i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t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-test. </a:t>
            </a:r>
            <a:endParaRPr lang="ja-JP" sz="1400" kern="10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A079977C-975F-1B44-AF5D-7328E740AD9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61084" y="1034910"/>
            <a:ext cx="1836777" cy="2004712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CC49CDF2-23F0-9747-B2A4-8DF5F9FE285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76948" y="1078416"/>
            <a:ext cx="2946400" cy="1917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389364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9801</TotalTime>
  <Words>145</Words>
  <Application>Microsoft Macintosh PowerPoint</Application>
  <PresentationFormat>A4 Paper (210x297 mm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ＭＳ 明朝</vt:lpstr>
      <vt:lpstr>ＭＳ 明朝</vt:lpstr>
      <vt:lpstr>游明朝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田中 良法</dc:creator>
  <cp:lastModifiedBy>田中 良法</cp:lastModifiedBy>
  <cp:revision>1568</cp:revision>
  <cp:lastPrinted>2022-02-10T10:10:52Z</cp:lastPrinted>
  <dcterms:created xsi:type="dcterms:W3CDTF">2020-08-12T02:53:40Z</dcterms:created>
  <dcterms:modified xsi:type="dcterms:W3CDTF">2024-03-11T14:28:10Z</dcterms:modified>
</cp:coreProperties>
</file>